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78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1ED9E8-790C-454C-A4E1-BC7237EDCD08}" type="datetimeFigureOut">
              <a:rPr lang="zh-CN" altLang="en-US" smtClean="0"/>
              <a:t>2022/2/19 Saturday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4F9608-FAB6-4D5A-8842-57DA4FFC2F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21891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504902B-EAE9-4181-837A-BD57DE68B36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9AA70B4-2464-4DC8-A653-B2549201705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E736EEF-107A-4EBA-9A4D-9BFBB0FCBF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FF259-1535-4E0F-BA8F-BBD1554E285D}" type="datetime1">
              <a:rPr lang="zh-CN" altLang="en-US" smtClean="0"/>
              <a:t>2022/2/19 Satur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37AC238-F091-40E4-B39B-0BA7DAFFAC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8731461-ADF3-47CD-969F-93721B8F93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2AF8A-5F7B-4D14-96B7-7EAF3ADD06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15015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DD494FB-79AB-4EBC-B7BF-3ABA24EA9C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86C6F26-AD8C-46D2-BDCA-1F367E7051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B6082B2-E534-4CDC-B42C-24314AAA3D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6AA45-D99E-4763-85F4-4F93000F916C}" type="datetime1">
              <a:rPr lang="zh-CN" altLang="en-US" smtClean="0"/>
              <a:t>2022/2/19 Satur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C7B6950-0807-4228-818D-F4AAD54643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1D8A488-3512-4EF4-A301-9FE1F9A974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2AF8A-5F7B-4D14-96B7-7EAF3ADD06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2301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ADEAD87-7BB8-41CF-8470-0992CA494E5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62B3421-40C3-49CB-80E6-74B01886FE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58503FA-4CE0-4541-B31B-E3CFBF20EC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AFD68-6D3E-4B57-9AFC-D72B361E97B0}" type="datetime1">
              <a:rPr lang="zh-CN" altLang="en-US" smtClean="0"/>
              <a:t>2022/2/19 Satur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80D721A-520E-4642-8E17-BA047918D0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BA843D9-DFEC-43DC-A29B-911EB15D6F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2AF8A-5F7B-4D14-96B7-7EAF3ADD06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47562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144E20A-BCEA-4C94-AD3B-2F9A2ECEF6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1CF6B11-EFF3-4989-B788-D98F2AB67FE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FABFDBC-C016-4461-98C9-47459D528E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92B7C-BB72-4AC7-8576-B811E6BFF548}" type="datetime1">
              <a:rPr lang="zh-CN" altLang="en-US" smtClean="0"/>
              <a:t>2022/2/19 Satur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BAC924E-A1BD-46A1-B43A-48DD3DF7D9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EF874CB-D258-45CF-973F-9CF2FF4953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2AF8A-5F7B-4D14-96B7-7EAF3ADD06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7248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B755BD2-78D8-463C-9DA6-C2B8799FC3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FD5EF8A-C93B-4558-ABE1-EAB6462FBD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4458599-EA57-4930-A923-463987A1B3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64CFA-3EC6-4D34-8A22-EC1EC509276F}" type="datetime1">
              <a:rPr lang="zh-CN" altLang="en-US" smtClean="0"/>
              <a:t>2022/2/19 Satur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E914EBD-9053-4241-AD32-3A24C142D1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FA8B45B-62B0-4D6A-A2A4-D9D2D79D33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2AF8A-5F7B-4D14-96B7-7EAF3ADD06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39454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9539FA0-626A-4A26-93C1-2B4DB6F63E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6053C82-B724-44F2-8948-F182C103598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F38A6C1-9A8C-4D0E-9AED-E66ACD434D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B2BC4FA-4BC4-4FD5-B4B7-041BD4178C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F88EB-C7BC-437F-978B-06B4789C2EF1}" type="datetime1">
              <a:rPr lang="zh-CN" altLang="en-US" smtClean="0"/>
              <a:t>2022/2/19 Saturday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0A7BE0A-1570-46F3-B3DC-67B25B5407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44FCBDE-7302-4F00-866D-FE0BFBCBA2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2AF8A-5F7B-4D14-96B7-7EAF3ADD06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02236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2523AB0-A028-4C81-9F01-20585481E4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D868780-10F9-4B55-A85A-E25C048E74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8FFBC93-2FF1-4ABD-A1DC-533243D36C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9705577-86FE-45F9-AF1B-B50991B5EB8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EF2D65BD-7EDC-449A-9318-38086081EDC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A53A1A7-7F6B-4407-91E7-554C72489D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08DC5-7BCF-45C5-BC6E-F46190C1E577}" type="datetime1">
              <a:rPr lang="zh-CN" altLang="en-US" smtClean="0"/>
              <a:t>2022/2/19 Saturday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BCBB791-3462-4557-93E6-F38E4E6649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EA3C01A-6BD9-4AF1-B9C4-01A63F3677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2AF8A-5F7B-4D14-96B7-7EAF3ADD06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386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06A76B9-974C-49B1-82FB-87A37E6165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CED96CE-ED85-4671-B418-38BDB879FB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74D0A-A75B-42F8-B394-6184638FC46F}" type="datetime1">
              <a:rPr lang="zh-CN" altLang="en-US" smtClean="0"/>
              <a:t>2022/2/19 Saturday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32D6350-E043-4455-961F-BCD881A0A4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4F779FF-85C5-4ED4-AD6F-FF924E72FE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2AF8A-5F7B-4D14-96B7-7EAF3ADD06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69300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C8A3A23-85BA-488E-ACA0-B6888560C2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FB7117-4A4B-495A-9B27-5D69B3AD87BE}" type="datetime1">
              <a:rPr lang="zh-CN" altLang="en-US" smtClean="0"/>
              <a:t>2022/2/19 Saturday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6E4A43F-F1A6-47B3-A056-559C5B56AF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B000B91-D4FB-4759-BAF8-F355D1DE0E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2AF8A-5F7B-4D14-96B7-7EAF3ADD06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87667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0BF289E-2363-4B9A-BC8B-7C95B7FE51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653B683-4826-4142-B259-3FC0EB495DC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371853A-97E9-4914-93A2-92100CB15E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15A08B5-624A-4560-82A0-FCDB0A38DE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9D50E7-BB83-4F3B-9765-776F9853620E}" type="datetime1">
              <a:rPr lang="zh-CN" altLang="en-US" smtClean="0"/>
              <a:t>2022/2/19 Saturday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E32204F-0E99-4959-8B59-240F7F0A88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67D0C3F-C533-4C40-B43A-7846806B0A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2AF8A-5F7B-4D14-96B7-7EAF3ADD06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23099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4855604-3B2E-474D-8F79-0D0061C9A7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5CA0265-B977-4C6E-86B5-F6A39D2D50C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899B38C-546D-48A3-B550-44FD2C912D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5C86C5D-F357-4C7C-B045-EDED333857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3417F-8BB9-45EE-A881-1EEE3D3E932E}" type="datetime1">
              <a:rPr lang="zh-CN" altLang="en-US" smtClean="0"/>
              <a:t>2022/2/19 Saturday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3445377-D32F-483F-A5F0-944FD6C006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DFE9220-C8E3-49BE-8AE6-54404A5CEA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2AF8A-5F7B-4D14-96B7-7EAF3ADD06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59951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14728AB-556D-4212-A884-5A40F636BF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6A4A4BA-14C1-4307-9391-3A1AE5AE4E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774C855-0F8B-4D3C-98A4-CEC4B0AFC44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16DDDF-340E-4772-A416-017C861B80BB}" type="datetime1">
              <a:rPr lang="zh-CN" altLang="en-US" smtClean="0"/>
              <a:t>2022/2/19 Satur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7E00115-BB09-42FB-A582-D66EDB5B940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B220622-6621-4FAA-9553-60F7471AD6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82AF8A-5F7B-4D14-96B7-7EAF3ADD06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847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>
            <a:extLst>
              <a:ext uri="{FF2B5EF4-FFF2-40B4-BE49-F238E27FC236}">
                <a16:creationId xmlns:a16="http://schemas.microsoft.com/office/drawing/2014/main" id="{D5780E8D-0324-4F9B-86B3-AD23F973196A}"/>
              </a:ext>
            </a:extLst>
          </p:cNvPr>
          <p:cNvSpPr/>
          <p:nvPr/>
        </p:nvSpPr>
        <p:spPr>
          <a:xfrm>
            <a:off x="482834" y="440174"/>
            <a:ext cx="2193229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4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napyl</a:t>
            </a:r>
            <a:r>
              <a:rPr lang="en-US" altLang="zh-CN" sz="2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lcohol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组合 6">
            <a:extLst>
              <a:ext uri="{FF2B5EF4-FFF2-40B4-BE49-F238E27FC236}">
                <a16:creationId xmlns:a16="http://schemas.microsoft.com/office/drawing/2014/main" id="{9E954DF0-97DD-4190-87E1-4DA863881472}"/>
              </a:ext>
            </a:extLst>
          </p:cNvPr>
          <p:cNvGrpSpPr/>
          <p:nvPr/>
        </p:nvGrpSpPr>
        <p:grpSpPr>
          <a:xfrm>
            <a:off x="1523603" y="1654910"/>
            <a:ext cx="9144793" cy="3548180"/>
            <a:chOff x="1523603" y="1654910"/>
            <a:chExt cx="9144793" cy="3548180"/>
          </a:xfrm>
        </p:grpSpPr>
        <p:pic>
          <p:nvPicPr>
            <p:cNvPr id="2" name="图片 1">
              <a:extLst>
                <a:ext uri="{FF2B5EF4-FFF2-40B4-BE49-F238E27FC236}">
                  <a16:creationId xmlns:a16="http://schemas.microsoft.com/office/drawing/2014/main" id="{74E2A94E-D150-4890-B4D3-240D85C49A4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23603" y="1654910"/>
              <a:ext cx="9144793" cy="3548180"/>
            </a:xfrm>
            <a:prstGeom prst="rect">
              <a:avLst/>
            </a:prstGeom>
          </p:spPr>
        </p:pic>
        <p:sp>
          <p:nvSpPr>
            <p:cNvPr id="4" name="矩形 3">
              <a:extLst>
                <a:ext uri="{FF2B5EF4-FFF2-40B4-BE49-F238E27FC236}">
                  <a16:creationId xmlns:a16="http://schemas.microsoft.com/office/drawing/2014/main" id="{6275956C-F984-4D33-924C-D571547A660C}"/>
                </a:ext>
              </a:extLst>
            </p:cNvPr>
            <p:cNvSpPr/>
            <p:nvPr/>
          </p:nvSpPr>
          <p:spPr>
            <a:xfrm>
              <a:off x="5844370" y="4168894"/>
              <a:ext cx="270619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lang="en-US" altLang="zh-CN" sz="14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+Sinapyl </a:t>
              </a:r>
              <a:r>
                <a:rPr lang="en-US" altLang="zh-CN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lcohol+Acetyl-CoA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矩形 4">
              <a:extLst>
                <a:ext uri="{FF2B5EF4-FFF2-40B4-BE49-F238E27FC236}">
                  <a16:creationId xmlns:a16="http://schemas.microsoft.com/office/drawing/2014/main" id="{8001F1A6-E4B5-4C97-8F9E-0C661D51E5BE}"/>
                </a:ext>
              </a:extLst>
            </p:cNvPr>
            <p:cNvSpPr/>
            <p:nvPr/>
          </p:nvSpPr>
          <p:spPr>
            <a:xfrm>
              <a:off x="6383909" y="4532103"/>
              <a:ext cx="176888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cCFAT+Acetyl-CoA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1B8BE6AE-786A-47E7-8F8C-A22BE4D3D724}"/>
                </a:ext>
              </a:extLst>
            </p:cNvPr>
            <p:cNvSpPr/>
            <p:nvPr/>
          </p:nvSpPr>
          <p:spPr>
            <a:xfrm>
              <a:off x="5705839" y="3820627"/>
              <a:ext cx="299197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cCFAT+Sinapyl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lcohol+Acetyl-CoA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8" name="矩形 7">
            <a:extLst>
              <a:ext uri="{FF2B5EF4-FFF2-40B4-BE49-F238E27FC236}">
                <a16:creationId xmlns:a16="http://schemas.microsoft.com/office/drawing/2014/main" id="{DBEF01E7-E997-4927-B170-F6DCFA8D55A2}"/>
              </a:ext>
            </a:extLst>
          </p:cNvPr>
          <p:cNvSpPr/>
          <p:nvPr/>
        </p:nvSpPr>
        <p:spPr>
          <a:xfrm>
            <a:off x="4235116" y="3429000"/>
            <a:ext cx="606391" cy="18745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7658511-4A71-4B3D-A408-14169F1A35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2AF8A-5F7B-4D14-96B7-7EAF3ADD06F8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75133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矩形 10">
            <a:extLst>
              <a:ext uri="{FF2B5EF4-FFF2-40B4-BE49-F238E27FC236}">
                <a16:creationId xmlns:a16="http://schemas.microsoft.com/office/drawing/2014/main" id="{DD093275-3D33-4F2D-B856-050C451F6AA8}"/>
              </a:ext>
            </a:extLst>
          </p:cNvPr>
          <p:cNvSpPr/>
          <p:nvPr/>
        </p:nvSpPr>
        <p:spPr>
          <a:xfrm>
            <a:off x="482834" y="440174"/>
            <a:ext cx="2791149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2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umaryl</a:t>
            </a:r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cohol</a:t>
            </a:r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6B94A13A-14B8-40F5-B291-A6FBBFDD257C}"/>
              </a:ext>
            </a:extLst>
          </p:cNvPr>
          <p:cNvGrpSpPr/>
          <p:nvPr/>
        </p:nvGrpSpPr>
        <p:grpSpPr>
          <a:xfrm>
            <a:off x="1524000" y="1931665"/>
            <a:ext cx="9144000" cy="2994671"/>
            <a:chOff x="1524000" y="1931665"/>
            <a:chExt cx="9144000" cy="2994671"/>
          </a:xfrm>
        </p:grpSpPr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210721A6-CC26-4797-B493-449E6507E74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24000" y="1931665"/>
              <a:ext cx="9144000" cy="2994671"/>
            </a:xfrm>
            <a:prstGeom prst="rect">
              <a:avLst/>
            </a:prstGeom>
          </p:spPr>
        </p:pic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CDD1DE0E-C07F-4EF1-A672-8A4A42D4614F}"/>
                </a:ext>
              </a:extLst>
            </p:cNvPr>
            <p:cNvSpPr/>
            <p:nvPr/>
          </p:nvSpPr>
          <p:spPr>
            <a:xfrm>
              <a:off x="5824548" y="3369997"/>
              <a:ext cx="3694266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lang="en-US" altLang="zh-CN" sz="14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+</a:t>
              </a:r>
              <a:r>
                <a:rPr lang="en-US" altLang="zh-CN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Coumaryl </a:t>
              </a:r>
              <a:r>
                <a:rPr lang="en-US" altLang="zh-CN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lcohol+Acetyl-CoA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矩形 12">
              <a:extLst>
                <a:ext uri="{FF2B5EF4-FFF2-40B4-BE49-F238E27FC236}">
                  <a16:creationId xmlns:a16="http://schemas.microsoft.com/office/drawing/2014/main" id="{E2C8EBBC-EA75-475A-9C2D-006A5EC40B8D}"/>
                </a:ext>
              </a:extLst>
            </p:cNvPr>
            <p:cNvSpPr/>
            <p:nvPr/>
          </p:nvSpPr>
          <p:spPr>
            <a:xfrm>
              <a:off x="6016196" y="3801889"/>
              <a:ext cx="331097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cCFAT+</a:t>
              </a:r>
              <a:r>
                <a:rPr lang="en-US" altLang="zh-CN" sz="14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zh-CN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-Coumaryl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lcohol+Acetyl-CoA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矩形 13">
              <a:extLst>
                <a:ext uri="{FF2B5EF4-FFF2-40B4-BE49-F238E27FC236}">
                  <a16:creationId xmlns:a16="http://schemas.microsoft.com/office/drawing/2014/main" id="{5C271AC1-B124-4245-8288-C8D3B8BF9D29}"/>
                </a:ext>
              </a:extLst>
            </p:cNvPr>
            <p:cNvSpPr/>
            <p:nvPr/>
          </p:nvSpPr>
          <p:spPr>
            <a:xfrm>
              <a:off x="6858798" y="2935105"/>
              <a:ext cx="1625765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lang="en-US" altLang="zh-CN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umaryl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lcohol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矩形 14">
              <a:extLst>
                <a:ext uri="{FF2B5EF4-FFF2-40B4-BE49-F238E27FC236}">
                  <a16:creationId xmlns:a16="http://schemas.microsoft.com/office/drawing/2014/main" id="{C94BD0BF-9C26-402D-9EC8-D42C3E018647}"/>
                </a:ext>
              </a:extLst>
            </p:cNvPr>
            <p:cNvSpPr/>
            <p:nvPr/>
          </p:nvSpPr>
          <p:spPr>
            <a:xfrm>
              <a:off x="6016196" y="4267471"/>
              <a:ext cx="331097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cCFAT+</a:t>
              </a:r>
              <a:r>
                <a:rPr lang="en-US" altLang="zh-CN" sz="14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zh-CN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-Coumaryl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lcohol+Acetyl-CoA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7" name="矩形 16">
            <a:extLst>
              <a:ext uri="{FF2B5EF4-FFF2-40B4-BE49-F238E27FC236}">
                <a16:creationId xmlns:a16="http://schemas.microsoft.com/office/drawing/2014/main" id="{2315570D-611E-4ADC-BA97-8E0B530EABC0}"/>
              </a:ext>
            </a:extLst>
          </p:cNvPr>
          <p:cNvSpPr/>
          <p:nvPr/>
        </p:nvSpPr>
        <p:spPr>
          <a:xfrm>
            <a:off x="4263992" y="2308849"/>
            <a:ext cx="440246" cy="29946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灯片编号占位符 1">
            <a:extLst>
              <a:ext uri="{FF2B5EF4-FFF2-40B4-BE49-F238E27FC236}">
                <a16:creationId xmlns:a16="http://schemas.microsoft.com/office/drawing/2014/main" id="{73D1C014-5222-45B2-B77D-0B2A287613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2AF8A-5F7B-4D14-96B7-7EAF3ADD06F8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5024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6D53C53C-3E2A-4914-B5C2-89B74CE1A0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4000" y="1931665"/>
            <a:ext cx="9144000" cy="2994671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8B654CF5-3EC5-4A69-BE47-AC8C49B5054D}"/>
              </a:ext>
            </a:extLst>
          </p:cNvPr>
          <p:cNvSpPr/>
          <p:nvPr/>
        </p:nvSpPr>
        <p:spPr>
          <a:xfrm>
            <a:off x="482834" y="440174"/>
            <a:ext cx="4641848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2400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zh-CN" sz="2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-3-phenyl-2-methyl-2-propenol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44BD6187-30EA-4604-984E-868AFEB8E93D}"/>
              </a:ext>
            </a:extLst>
          </p:cNvPr>
          <p:cNvSpPr/>
          <p:nvPr/>
        </p:nvSpPr>
        <p:spPr>
          <a:xfrm>
            <a:off x="5150776" y="3706878"/>
            <a:ext cx="553326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altLang="zh-CN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+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4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-3-phenyl-2-methyl-2-propenol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Acetyl-Co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05AA3BF1-F5F9-47D2-929D-7DB4ED15D176}"/>
              </a:ext>
            </a:extLst>
          </p:cNvPr>
          <p:cNvSpPr/>
          <p:nvPr/>
        </p:nvSpPr>
        <p:spPr>
          <a:xfrm>
            <a:off x="4938962" y="4042517"/>
            <a:ext cx="595689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CFAT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4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-3-phenyl-2-methyl-2-propenol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Acetyl-Co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5D67E78C-9480-4507-B9D4-19D3632C208F}"/>
              </a:ext>
            </a:extLst>
          </p:cNvPr>
          <p:cNvSpPr/>
          <p:nvPr/>
        </p:nvSpPr>
        <p:spPr>
          <a:xfrm>
            <a:off x="6449698" y="3377864"/>
            <a:ext cx="266290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4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-3-phenyl-2-methyl-2-propenol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4B7959B7-2BCF-4BEF-9F8F-FE0010C78543}"/>
              </a:ext>
            </a:extLst>
          </p:cNvPr>
          <p:cNvSpPr/>
          <p:nvPr/>
        </p:nvSpPr>
        <p:spPr>
          <a:xfrm>
            <a:off x="5083341" y="4363721"/>
            <a:ext cx="566813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CFAT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4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-3-phenyl-2-methyl-2-propenol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Acetyl-Co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B6D41CF4-4CFA-4599-95CC-7E4989A78BF8}"/>
              </a:ext>
            </a:extLst>
          </p:cNvPr>
          <p:cNvSpPr/>
          <p:nvPr/>
        </p:nvSpPr>
        <p:spPr>
          <a:xfrm>
            <a:off x="4957014" y="3140241"/>
            <a:ext cx="248301" cy="18745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灯片编号占位符 2">
            <a:extLst>
              <a:ext uri="{FF2B5EF4-FFF2-40B4-BE49-F238E27FC236}">
                <a16:creationId xmlns:a16="http://schemas.microsoft.com/office/drawing/2014/main" id="{27E33B9F-8E2B-4A17-AC12-D5A9C59C64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2AF8A-5F7B-4D14-96B7-7EAF3ADD06F8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55488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D91FD68D-6677-494C-9424-752A937FA75C}"/>
              </a:ext>
            </a:extLst>
          </p:cNvPr>
          <p:cNvSpPr/>
          <p:nvPr/>
        </p:nvSpPr>
        <p:spPr>
          <a:xfrm>
            <a:off x="482834" y="440174"/>
            <a:ext cx="2089033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enzyl alcohol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" name="组合 8">
            <a:extLst>
              <a:ext uri="{FF2B5EF4-FFF2-40B4-BE49-F238E27FC236}">
                <a16:creationId xmlns:a16="http://schemas.microsoft.com/office/drawing/2014/main" id="{7DE3D8B2-1BB6-4F0A-8ED3-85BD9E33B696}"/>
              </a:ext>
            </a:extLst>
          </p:cNvPr>
          <p:cNvGrpSpPr/>
          <p:nvPr/>
        </p:nvGrpSpPr>
        <p:grpSpPr>
          <a:xfrm>
            <a:off x="1410074" y="776712"/>
            <a:ext cx="9371853" cy="2980157"/>
            <a:chOff x="1524000" y="1938922"/>
            <a:chExt cx="9371853" cy="2980157"/>
          </a:xfrm>
        </p:grpSpPr>
        <p:pic>
          <p:nvPicPr>
            <p:cNvPr id="2" name="图片 1">
              <a:extLst>
                <a:ext uri="{FF2B5EF4-FFF2-40B4-BE49-F238E27FC236}">
                  <a16:creationId xmlns:a16="http://schemas.microsoft.com/office/drawing/2014/main" id="{C640FC80-A218-406C-8A76-A39B68AA2E3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24000" y="1938922"/>
              <a:ext cx="9144000" cy="2980157"/>
            </a:xfrm>
            <a:prstGeom prst="rect">
              <a:avLst/>
            </a:prstGeom>
          </p:spPr>
        </p:pic>
        <p:sp>
          <p:nvSpPr>
            <p:cNvPr id="5" name="矩形 4">
              <a:extLst>
                <a:ext uri="{FF2B5EF4-FFF2-40B4-BE49-F238E27FC236}">
                  <a16:creationId xmlns:a16="http://schemas.microsoft.com/office/drawing/2014/main" id="{5DF77D70-72B7-4093-B72A-90B13043B8C9}"/>
                </a:ext>
              </a:extLst>
            </p:cNvPr>
            <p:cNvSpPr/>
            <p:nvPr/>
          </p:nvSpPr>
          <p:spPr>
            <a:xfrm>
              <a:off x="5150776" y="3466243"/>
              <a:ext cx="5533263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lang="en-US" altLang="zh-CN" sz="14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+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enzyl </a:t>
              </a:r>
              <a:r>
                <a:rPr lang="en-US" altLang="zh-CN" sz="1400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lcohol</a:t>
              </a:r>
              <a:r>
                <a:rPr lang="en-US" altLang="zh-CN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+Acetyl-CoA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0FB2B8E2-53AC-4E65-A44F-F015100FC02E}"/>
                </a:ext>
              </a:extLst>
            </p:cNvPr>
            <p:cNvSpPr/>
            <p:nvPr/>
          </p:nvSpPr>
          <p:spPr>
            <a:xfrm>
              <a:off x="4938962" y="3869262"/>
              <a:ext cx="5956891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cCFAT+</a:t>
              </a:r>
              <a:r>
                <a:rPr lang="en-US" altLang="zh-CN" sz="1400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enzyl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lcohol</a:t>
              </a:r>
              <a:r>
                <a:rPr lang="en-US" altLang="zh-CN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+Acetyl-CoA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46214A2D-40DA-4E11-AA09-50603B7B2BF7}"/>
                </a:ext>
              </a:extLst>
            </p:cNvPr>
            <p:cNvSpPr/>
            <p:nvPr/>
          </p:nvSpPr>
          <p:spPr>
            <a:xfrm>
              <a:off x="7283259" y="3064800"/>
              <a:ext cx="1268296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enzyl alcohol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矩形 7">
              <a:extLst>
                <a:ext uri="{FF2B5EF4-FFF2-40B4-BE49-F238E27FC236}">
                  <a16:creationId xmlns:a16="http://schemas.microsoft.com/office/drawing/2014/main" id="{97165743-2F2D-4361-950D-F6FA9A6F3DFA}"/>
                </a:ext>
              </a:extLst>
            </p:cNvPr>
            <p:cNvSpPr/>
            <p:nvPr/>
          </p:nvSpPr>
          <p:spPr>
            <a:xfrm>
              <a:off x="5083341" y="4315596"/>
              <a:ext cx="5668133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cCFAT+</a:t>
              </a:r>
              <a:r>
                <a:rPr lang="en-US" altLang="zh-CN" sz="1400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enzyl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lcohol</a:t>
              </a:r>
              <a:r>
                <a:rPr lang="en-US" altLang="zh-CN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+Acetyl-CoA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9A3B46AC-A467-4743-9A49-A1ED124696BE}"/>
              </a:ext>
            </a:extLst>
          </p:cNvPr>
          <p:cNvGrpSpPr/>
          <p:nvPr/>
        </p:nvGrpSpPr>
        <p:grpSpPr>
          <a:xfrm>
            <a:off x="1408500" y="3738727"/>
            <a:ext cx="9229048" cy="2994671"/>
            <a:chOff x="1408500" y="3738727"/>
            <a:chExt cx="9229048" cy="2994671"/>
          </a:xfrm>
        </p:grpSpPr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154FADD0-0162-4D11-AB10-E8F72A364AF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408500" y="3738727"/>
              <a:ext cx="9144000" cy="2994671"/>
            </a:xfrm>
            <a:prstGeom prst="rect">
              <a:avLst/>
            </a:prstGeom>
          </p:spPr>
        </p:pic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443D079B-F954-4735-9B9D-FF1C8E44D0D7}"/>
                </a:ext>
              </a:extLst>
            </p:cNvPr>
            <p:cNvSpPr/>
            <p:nvPr/>
          </p:nvSpPr>
          <p:spPr>
            <a:xfrm>
              <a:off x="7223835" y="4780140"/>
              <a:ext cx="115929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enzyl aetate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矩形 18">
              <a:extLst>
                <a:ext uri="{FF2B5EF4-FFF2-40B4-BE49-F238E27FC236}">
                  <a16:creationId xmlns:a16="http://schemas.microsoft.com/office/drawing/2014/main" id="{BEFDC9B5-0CE0-4DED-AC7C-56F42812BC44}"/>
                </a:ext>
              </a:extLst>
            </p:cNvPr>
            <p:cNvSpPr/>
            <p:nvPr/>
          </p:nvSpPr>
          <p:spPr>
            <a:xfrm>
              <a:off x="5036850" y="5419936"/>
              <a:ext cx="5533263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lang="en-US" altLang="zh-CN" sz="14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+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enzyl </a:t>
              </a:r>
              <a:r>
                <a:rPr lang="en-US" altLang="zh-CN" sz="1400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lcohol</a:t>
              </a:r>
              <a:r>
                <a:rPr lang="en-US" altLang="zh-CN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+Acetyl-CoA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矩形 19">
              <a:extLst>
                <a:ext uri="{FF2B5EF4-FFF2-40B4-BE49-F238E27FC236}">
                  <a16:creationId xmlns:a16="http://schemas.microsoft.com/office/drawing/2014/main" id="{97301FED-0924-4D58-9753-137484CDB766}"/>
                </a:ext>
              </a:extLst>
            </p:cNvPr>
            <p:cNvSpPr/>
            <p:nvPr/>
          </p:nvSpPr>
          <p:spPr>
            <a:xfrm>
              <a:off x="4969415" y="6076667"/>
              <a:ext cx="5668133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cCFAT+</a:t>
              </a:r>
              <a:r>
                <a:rPr lang="en-US" altLang="zh-CN" sz="1400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enzyl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lcohol</a:t>
              </a:r>
              <a:r>
                <a:rPr lang="en-US" altLang="zh-CN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+Acetyl-CoA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2" name="矩形 21">
            <a:extLst>
              <a:ext uri="{FF2B5EF4-FFF2-40B4-BE49-F238E27FC236}">
                <a16:creationId xmlns:a16="http://schemas.microsoft.com/office/drawing/2014/main" id="{FB84D4A0-4AB8-4C75-8167-16AAFF9EBBCD}"/>
              </a:ext>
            </a:extLst>
          </p:cNvPr>
          <p:cNvSpPr/>
          <p:nvPr/>
        </p:nvSpPr>
        <p:spPr>
          <a:xfrm>
            <a:off x="4533499" y="1864207"/>
            <a:ext cx="206489" cy="18745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B79B2FD0-CF10-4D8C-AD6F-0094412080FD}"/>
              </a:ext>
            </a:extLst>
          </p:cNvPr>
          <p:cNvSpPr/>
          <p:nvPr/>
        </p:nvSpPr>
        <p:spPr>
          <a:xfrm>
            <a:off x="4533499" y="3888962"/>
            <a:ext cx="206489" cy="2880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灯片编号占位符 2">
            <a:extLst>
              <a:ext uri="{FF2B5EF4-FFF2-40B4-BE49-F238E27FC236}">
                <a16:creationId xmlns:a16="http://schemas.microsoft.com/office/drawing/2014/main" id="{262EAA60-429A-40DF-8EE3-67F2D79143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2AF8A-5F7B-4D14-96B7-7EAF3ADD06F8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31187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49232007-150D-4DEE-B88D-C90F5C633AF2}"/>
              </a:ext>
            </a:extLst>
          </p:cNvPr>
          <p:cNvSpPr/>
          <p:nvPr/>
        </p:nvSpPr>
        <p:spPr>
          <a:xfrm>
            <a:off x="482834" y="440174"/>
            <a:ext cx="346845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-Hydroxybenzyl alcohol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" name="组合 8">
            <a:extLst>
              <a:ext uri="{FF2B5EF4-FFF2-40B4-BE49-F238E27FC236}">
                <a16:creationId xmlns:a16="http://schemas.microsoft.com/office/drawing/2014/main" id="{1E2AD8E4-E508-409A-A678-1DB88A7408B9}"/>
              </a:ext>
            </a:extLst>
          </p:cNvPr>
          <p:cNvGrpSpPr/>
          <p:nvPr/>
        </p:nvGrpSpPr>
        <p:grpSpPr>
          <a:xfrm>
            <a:off x="74323" y="1070811"/>
            <a:ext cx="12043355" cy="4716379"/>
            <a:chOff x="74323" y="1070811"/>
            <a:chExt cx="12043355" cy="4716379"/>
          </a:xfrm>
        </p:grpSpPr>
        <p:pic>
          <p:nvPicPr>
            <p:cNvPr id="2" name="图片 1">
              <a:extLst>
                <a:ext uri="{FF2B5EF4-FFF2-40B4-BE49-F238E27FC236}">
                  <a16:creationId xmlns:a16="http://schemas.microsoft.com/office/drawing/2014/main" id="{2CB026B1-4CE1-4C94-B618-143118D7FF4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4323" y="1070811"/>
              <a:ext cx="12043355" cy="4716379"/>
            </a:xfrm>
            <a:prstGeom prst="rect">
              <a:avLst/>
            </a:prstGeom>
          </p:spPr>
        </p:pic>
        <p:sp>
          <p:nvSpPr>
            <p:cNvPr id="5" name="矩形 4">
              <a:extLst>
                <a:ext uri="{FF2B5EF4-FFF2-40B4-BE49-F238E27FC236}">
                  <a16:creationId xmlns:a16="http://schemas.microsoft.com/office/drawing/2014/main" id="{2EB86758-F341-42DE-93A0-460BBB379E84}"/>
                </a:ext>
              </a:extLst>
            </p:cNvPr>
            <p:cNvSpPr/>
            <p:nvPr/>
          </p:nvSpPr>
          <p:spPr>
            <a:xfrm>
              <a:off x="5181228" y="4274259"/>
              <a:ext cx="5533263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lang="en-US" altLang="zh-CN" sz="14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+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-Hydroxybenzyl </a:t>
              </a:r>
              <a:r>
                <a:rPr lang="en-US" altLang="zh-CN" sz="1400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lcohol</a:t>
              </a:r>
              <a:r>
                <a:rPr lang="en-US" altLang="zh-CN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+Acetyl-CoA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3E70F3C8-746F-4E8F-87A2-D3A6E7CE08C6}"/>
                </a:ext>
              </a:extLst>
            </p:cNvPr>
            <p:cNvSpPr/>
            <p:nvPr/>
          </p:nvSpPr>
          <p:spPr>
            <a:xfrm>
              <a:off x="4969414" y="4628869"/>
              <a:ext cx="5956891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cCFAT+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-Hydroxybenzyl </a:t>
              </a:r>
              <a:r>
                <a:rPr lang="en-US" altLang="zh-CN" sz="1400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lcohol</a:t>
              </a:r>
              <a:r>
                <a:rPr lang="en-US" altLang="zh-CN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+Acetyl-CoA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E4995B23-783E-409B-BF9A-9A8917FE2703}"/>
                </a:ext>
              </a:extLst>
            </p:cNvPr>
            <p:cNvSpPr/>
            <p:nvPr/>
          </p:nvSpPr>
          <p:spPr>
            <a:xfrm>
              <a:off x="6845634" y="3919649"/>
              <a:ext cx="202491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-Hydroxybenzyl alcohol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矩形 7">
              <a:extLst>
                <a:ext uri="{FF2B5EF4-FFF2-40B4-BE49-F238E27FC236}">
                  <a16:creationId xmlns:a16="http://schemas.microsoft.com/office/drawing/2014/main" id="{A6269997-6AF9-47FA-A48F-5C8E37627BCE}"/>
                </a:ext>
              </a:extLst>
            </p:cNvPr>
            <p:cNvSpPr/>
            <p:nvPr/>
          </p:nvSpPr>
          <p:spPr>
            <a:xfrm>
              <a:off x="5113793" y="5030312"/>
              <a:ext cx="5668133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cCFAT+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-Hydroxybenzyl </a:t>
              </a:r>
              <a:r>
                <a:rPr lang="en-US" altLang="zh-CN" sz="1400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lcohol</a:t>
              </a:r>
              <a:r>
                <a:rPr lang="en-US" altLang="zh-CN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+Acetyl-CoA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0" name="矩形 9">
            <a:extLst>
              <a:ext uri="{FF2B5EF4-FFF2-40B4-BE49-F238E27FC236}">
                <a16:creationId xmlns:a16="http://schemas.microsoft.com/office/drawing/2014/main" id="{5F6A9456-A1C2-4F4D-8E34-7C60B24C5871}"/>
              </a:ext>
            </a:extLst>
          </p:cNvPr>
          <p:cNvSpPr/>
          <p:nvPr/>
        </p:nvSpPr>
        <p:spPr>
          <a:xfrm>
            <a:off x="3427173" y="3691609"/>
            <a:ext cx="206489" cy="18745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灯片编号占位符 2">
            <a:extLst>
              <a:ext uri="{FF2B5EF4-FFF2-40B4-BE49-F238E27FC236}">
                <a16:creationId xmlns:a16="http://schemas.microsoft.com/office/drawing/2014/main" id="{D21088C8-2B6F-4977-B160-DFDEFA0CED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2AF8A-5F7B-4D14-96B7-7EAF3ADD06F8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850695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>
            <a:extLst>
              <a:ext uri="{FF2B5EF4-FFF2-40B4-BE49-F238E27FC236}">
                <a16:creationId xmlns:a16="http://schemas.microsoft.com/office/drawing/2014/main" id="{0C648D1B-1E30-42C7-9AA6-5E31333C8FAE}"/>
              </a:ext>
            </a:extLst>
          </p:cNvPr>
          <p:cNvSpPr/>
          <p:nvPr/>
        </p:nvSpPr>
        <p:spPr>
          <a:xfrm>
            <a:off x="805037" y="440174"/>
            <a:ext cx="318792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+)-</a:t>
            </a:r>
            <a:r>
              <a:rPr lang="en-US" altLang="zh-CN" sz="24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coisolariciresinol</a:t>
            </a:r>
            <a:endParaRPr lang="en-US" altLang="zh-CN" sz="24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组合 6">
            <a:extLst>
              <a:ext uri="{FF2B5EF4-FFF2-40B4-BE49-F238E27FC236}">
                <a16:creationId xmlns:a16="http://schemas.microsoft.com/office/drawing/2014/main" id="{96E9C05A-DE4A-402C-9633-6B910CF628CE}"/>
              </a:ext>
            </a:extLst>
          </p:cNvPr>
          <p:cNvGrpSpPr/>
          <p:nvPr/>
        </p:nvGrpSpPr>
        <p:grpSpPr>
          <a:xfrm>
            <a:off x="1529346" y="1820491"/>
            <a:ext cx="9133308" cy="3217019"/>
            <a:chOff x="1529346" y="1820491"/>
            <a:chExt cx="9133308" cy="3217019"/>
          </a:xfrm>
        </p:grpSpPr>
        <p:pic>
          <p:nvPicPr>
            <p:cNvPr id="2" name="Picture 3">
              <a:extLst>
                <a:ext uri="{FF2B5EF4-FFF2-40B4-BE49-F238E27FC236}">
                  <a16:creationId xmlns:a16="http://schemas.microsoft.com/office/drawing/2014/main" id="{AEFE1187-633F-4735-A4C8-2AAF68967B1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29346" y="1820491"/>
              <a:ext cx="9133308" cy="32170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" name="矩形 3">
              <a:extLst>
                <a:ext uri="{FF2B5EF4-FFF2-40B4-BE49-F238E27FC236}">
                  <a16:creationId xmlns:a16="http://schemas.microsoft.com/office/drawing/2014/main" id="{00672A62-505E-4F7A-B2F7-F3B5D0846317}"/>
                </a:ext>
              </a:extLst>
            </p:cNvPr>
            <p:cNvSpPr/>
            <p:nvPr/>
          </p:nvSpPr>
          <p:spPr>
            <a:xfrm>
              <a:off x="4917577" y="3771589"/>
              <a:ext cx="5533263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lang="en-US" altLang="zh-CN" sz="14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+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+)-</a:t>
              </a:r>
              <a:r>
                <a:rPr lang="en-US" altLang="zh-CN" sz="1400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ecoisolariciresinol</a:t>
              </a:r>
              <a:endPara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矩形 4">
              <a:extLst>
                <a:ext uri="{FF2B5EF4-FFF2-40B4-BE49-F238E27FC236}">
                  <a16:creationId xmlns:a16="http://schemas.microsoft.com/office/drawing/2014/main" id="{23820466-C860-4A92-8E3B-0A74AECBE72C}"/>
                </a:ext>
              </a:extLst>
            </p:cNvPr>
            <p:cNvSpPr/>
            <p:nvPr/>
          </p:nvSpPr>
          <p:spPr>
            <a:xfrm>
              <a:off x="4705763" y="4421955"/>
              <a:ext cx="5956891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cCFAT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+)-</a:t>
              </a:r>
              <a:r>
                <a:rPr lang="en-US" altLang="zh-CN" sz="1400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ecoisolariciresinol</a:t>
              </a:r>
              <a:r>
                <a:rPr lang="en-US" altLang="zh-CN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+Acetyl-CoA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31795039-62B4-423C-B01A-CC34275F058A}"/>
                </a:ext>
              </a:extLst>
            </p:cNvPr>
            <p:cNvSpPr/>
            <p:nvPr/>
          </p:nvSpPr>
          <p:spPr>
            <a:xfrm>
              <a:off x="6743887" y="3090743"/>
              <a:ext cx="188064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+)-</a:t>
              </a:r>
              <a:r>
                <a:rPr lang="en-US" altLang="zh-CN" sz="1400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ecoisolariciresinol</a:t>
              </a:r>
              <a:endPara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8" name="灯片编号占位符 7">
            <a:extLst>
              <a:ext uri="{FF2B5EF4-FFF2-40B4-BE49-F238E27FC236}">
                <a16:creationId xmlns:a16="http://schemas.microsoft.com/office/drawing/2014/main" id="{908812CC-2ED2-4350-876F-D574DF302C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2AF8A-5F7B-4D14-96B7-7EAF3ADD06F8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43803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144</Words>
  <Application>Microsoft Office PowerPoint</Application>
  <PresentationFormat>宽屏</PresentationFormat>
  <Paragraphs>37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1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istrator</cp:lastModifiedBy>
  <cp:revision>12</cp:revision>
  <dcterms:created xsi:type="dcterms:W3CDTF">2022-01-11T12:19:15Z</dcterms:created>
  <dcterms:modified xsi:type="dcterms:W3CDTF">2022-02-19T09:23:50Z</dcterms:modified>
</cp:coreProperties>
</file>